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4"/>
  </p:notesMasterIdLst>
  <p:sldIdLst>
    <p:sldId id="289" r:id="rId2"/>
    <p:sldId id="296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25" userDrawn="1">
          <p15:clr>
            <a:srgbClr val="A4A3A4"/>
          </p15:clr>
        </p15:guide>
        <p15:guide id="2" pos="3885" userDrawn="1">
          <p15:clr>
            <a:srgbClr val="A4A3A4"/>
          </p15:clr>
        </p15:guide>
        <p15:guide id="3" pos="370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abriel Allo" initials="GA" lastIdx="7" clrIdx="0">
    <p:extLst>
      <p:ext uri="{19B8F6BF-5375-455C-9EA6-DF929625EA0E}">
        <p15:presenceInfo xmlns:p15="http://schemas.microsoft.com/office/powerpoint/2012/main" userId="1f41eac10771b087" providerId="Windows Live"/>
      </p:ext>
    </p:extLst>
  </p:cmAuthor>
  <p:cmAuthor id="2" name="Christoph Schumacher" initials="CS" lastIdx="4" clrIdx="1">
    <p:extLst>
      <p:ext uri="{19B8F6BF-5375-455C-9EA6-DF929625EA0E}">
        <p15:presenceInfo xmlns:p15="http://schemas.microsoft.com/office/powerpoint/2012/main" userId="d33b18372c66239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A1A1A1"/>
    <a:srgbClr val="E7E7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ittlere Formatvorlage 2 - Akz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DF18680-E054-41AD-8BC1-D1AEF772440D}" styleName="Mittlere Formatvorlage 2 - Akz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0A15C55-8517-42AA-B614-E9B94910E393}" styleName="Mittlere Formatvorlage 2 - Akz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F5AB1C69-6EDB-4FF4-983F-18BD219EF322}" styleName="Mittlere Formatvorlage 2 - Akz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6E25E649-3F16-4E02-A733-19D2CDBF48F0}" styleName="Mittlere Formatvorlage 3 - Akz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ittlere Formatvorlag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3296810-A885-4BE3-A3E7-6D5BEEA58F35}" styleName="Mittlere Formatvorlage 2 - Akz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EB9631B5-78F2-41C9-869B-9F39066F8104}" styleName="Mittlere Formatvorlage 3 - Akz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5A111915-BE36-4E01-A7E5-04B1672EAD32}" styleName="Helle Formatvorlage 2 - Akz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FABFCF23-3B69-468F-B69F-88F6DE6A72F2}" styleName="Mittlere Formatvorlage 1 - Akz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793D81CF-94F2-401A-BA57-92F5A7B2D0C5}" styleName="Mittlere Formatvorlag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7E9639D4-E3E2-4D34-9284-5A2195B3D0D7}" styleName="Helle Formatvorlag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D7AC3CCA-C797-4891-BE02-D94E43425B78}" styleName="Mittlere Formatvorlag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74C1A8A3-306A-4EB7-A6B1-4F7E0EB9C5D6}" styleName="Mittlere Formatvorlage 3 - Akz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73" autoAdjust="0"/>
    <p:restoredTop sz="96247" autoAdjust="0"/>
  </p:normalViewPr>
  <p:slideViewPr>
    <p:cSldViewPr snapToGrid="0" showGuides="1">
      <p:cViewPr varScale="1">
        <p:scale>
          <a:sx n="60" d="100"/>
          <a:sy n="60" d="100"/>
        </p:scale>
        <p:origin x="948" y="44"/>
      </p:cViewPr>
      <p:guideLst>
        <p:guide orient="horz" pos="1525"/>
        <p:guide pos="3885"/>
        <p:guide pos="37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 dirty="0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697E04-562C-48AC-B0DF-D29314CD78D0}" type="datetimeFigureOut">
              <a:rPr lang="de-DE" smtClean="0"/>
              <a:t>31.05.2026</a:t>
            </a:fld>
            <a:endParaRPr lang="de-DE" dirty="0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 dirty="0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D9BFC0-F1AB-4578-8B27-8CFB5FCC3B8D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2482780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D9BFC0-F1AB-4578-8B27-8CFB5FCC3B8D}" type="slidenum">
              <a:rPr lang="de-DE" smtClean="0"/>
              <a:t>1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7596414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D9BFC0-F1AB-4578-8B27-8CFB5FCC3B8D}" type="slidenum">
              <a:rPr lang="de-DE" smtClean="0"/>
              <a:t>2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9018911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6A0090B-2180-1357-FEA2-807A840DCA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4DFCBC34-B3C6-164D-34F4-42BE2D96F6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BDFFFF5-18B9-225C-B8D5-029264B35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776F-B453-4BA2-8EA7-CC8122B00E8A}" type="datetimeFigureOut">
              <a:rPr lang="de-DE" smtClean="0"/>
              <a:t>31.05.2026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D089FD1-12FB-E901-6182-AB7A199564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59D1A05-F31C-F8FB-0CC2-D67EF1FF2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243B7-592F-484F-AE41-8B9AA6081263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2658364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C33BCC1-618F-AF7A-FFC4-281EC83FD7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9C04B8DF-6B4B-6684-7804-7F67755496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17BA6DD-FC56-FADF-3C64-BD72F660D7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776F-B453-4BA2-8EA7-CC8122B00E8A}" type="datetimeFigureOut">
              <a:rPr lang="de-DE" smtClean="0"/>
              <a:t>31.05.2026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32D331C-8017-8991-5053-E91AD05EDB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65AFDC3-4238-DFD6-34C6-69360036BF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243B7-592F-484F-AE41-8B9AA6081263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084219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F02BA315-23FE-5284-E1DD-CE86B3AD64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F35B7B5-2232-9885-398B-E211D04B32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F6A48EB-0EFD-C3A9-3669-01E0B02852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776F-B453-4BA2-8EA7-CC8122B00E8A}" type="datetimeFigureOut">
              <a:rPr lang="de-DE" smtClean="0"/>
              <a:t>31.05.2026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EDBABE5-971F-61A7-4540-1097BD09C3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25012A8-9A54-4026-CFC0-D0CA9B2C0A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243B7-592F-484F-AE41-8B9AA6081263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278901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37EAFDD-9268-A62A-7677-3D02F98564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FA4031E-A1F1-CFA2-FA8E-05D32BFF77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EF6533F-7C2C-57E9-6E7C-E93EA923E1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776F-B453-4BA2-8EA7-CC8122B00E8A}" type="datetimeFigureOut">
              <a:rPr lang="de-DE" smtClean="0"/>
              <a:t>31.05.2026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D66446F-4BBF-2140-868D-86A0D4C7AF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0420708-4004-A3E0-245F-EEC10F92B9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243B7-592F-484F-AE41-8B9AA6081263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6204459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A8EDBCF-E30F-4FE1-036A-DB7E10A9BC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7789EF9-A42F-0CB1-D25C-AD536806A1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649D5DA-64AA-FCB0-C912-E69E3D4397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776F-B453-4BA2-8EA7-CC8122B00E8A}" type="datetimeFigureOut">
              <a:rPr lang="de-DE" smtClean="0"/>
              <a:t>31.05.2026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601D5D5-6183-DC81-741D-7BAE892014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F3FC168-C9B4-CAD7-F8A0-E0AD914BA5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243B7-592F-484F-AE41-8B9AA6081263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2927773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688CE5F-9CE2-4893-42EB-164017D97F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15B56C0-AAD2-1A20-24AF-7D8559D036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F4F21C5-1177-3762-62DD-86B703D2BE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B92906F-22A2-4043-283F-1A6D07559A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776F-B453-4BA2-8EA7-CC8122B00E8A}" type="datetimeFigureOut">
              <a:rPr lang="de-DE" smtClean="0"/>
              <a:t>31.05.2026</a:t>
            </a:fld>
            <a:endParaRPr lang="de-DE" dirty="0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0EEEACF-49AA-EE7F-F746-8D26EA4311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3750E68-F288-CBAD-00AC-8BC0D49E23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243B7-592F-484F-AE41-8B9AA6081263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4760599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539564A-EC19-811E-80B1-373A85E079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F1E18C2-15A5-DAA3-38C7-7DB0B0EAC5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8128476C-D9A6-D21B-3309-17FC9AB077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A7273C41-1FA7-A47D-6C34-DD1A2F61988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8EAAE04-99AE-504C-99DA-08429A6B4A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6BBA4B82-C5C6-50F3-9B3A-D6349B7DDB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776F-B453-4BA2-8EA7-CC8122B00E8A}" type="datetimeFigureOut">
              <a:rPr lang="de-DE" smtClean="0"/>
              <a:t>31.05.2026</a:t>
            </a:fld>
            <a:endParaRPr lang="de-DE" dirty="0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F6387D69-6985-D946-EEA8-C015C2AAE8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D6A648AB-BD73-0D17-F067-EF355D723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243B7-592F-484F-AE41-8B9AA6081263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74696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B221199-1E2C-211E-4FA7-53921FB5AE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62F6DADD-B1F9-8C98-536F-AE7DCC7032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776F-B453-4BA2-8EA7-CC8122B00E8A}" type="datetimeFigureOut">
              <a:rPr lang="de-DE" smtClean="0"/>
              <a:t>31.05.2026</a:t>
            </a:fld>
            <a:endParaRPr lang="de-DE" dirty="0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E9358E5E-350A-AF8F-24DF-6479437276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3BE717F-8E9A-8D61-2B30-BC2570A2D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243B7-592F-484F-AE41-8B9AA6081263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520854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5DBE7846-28D5-2B04-98FF-953C96CA3B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776F-B453-4BA2-8EA7-CC8122B00E8A}" type="datetimeFigureOut">
              <a:rPr lang="de-DE" smtClean="0"/>
              <a:t>31.05.2026</a:t>
            </a:fld>
            <a:endParaRPr lang="de-DE" dirty="0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0FBA8A62-B131-48DE-512B-DFDB4B90BA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EB05BF87-2B03-D0AD-017F-BBC68DD3E1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243B7-592F-484F-AE41-8B9AA6081263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2553054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22DFD5D-8DB5-5CB7-4D33-6E257EA2C0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3185BD2-CF18-C671-D6B4-FDA6FF834B6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68F2174-D761-A1E1-FFA1-0B1A4362CE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BDD9F4D-2615-F65E-1E96-068AF4AB1B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776F-B453-4BA2-8EA7-CC8122B00E8A}" type="datetimeFigureOut">
              <a:rPr lang="de-DE" smtClean="0"/>
              <a:t>31.05.2026</a:t>
            </a:fld>
            <a:endParaRPr lang="de-DE" dirty="0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8E31BEF-499A-88A7-C3B9-E7937F3F53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F139435-F46B-BC7C-152C-EE902BFA8E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243B7-592F-484F-AE41-8B9AA6081263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910221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BC7F9CA-D421-1DFA-C75E-74DA91FCAF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8C3D6812-8004-DA22-13E1-D92B4F0568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 dirty="0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5A5D17D-E3A7-D281-A62D-0DFA43C7B5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6B68E5E-CAC9-EFF8-E402-5ACB92DCBE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E776F-B453-4BA2-8EA7-CC8122B00E8A}" type="datetimeFigureOut">
              <a:rPr lang="de-DE" smtClean="0"/>
              <a:t>31.05.2026</a:t>
            </a:fld>
            <a:endParaRPr lang="de-DE" dirty="0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3A4977A-97BE-08D5-F458-6CFA0DDDF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B6B12D0-AB47-46F3-DCDE-54B0BE94C5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4243B7-592F-484F-AE41-8B9AA6081263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28958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5E1057BB-832C-BF7D-E316-AAA04487C5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ED4C43A-9BC7-3BFE-569D-E17237CC0F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C380E24-1E6F-6467-A36E-AFB5C205E5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1E776F-B453-4BA2-8EA7-CC8122B00E8A}" type="datetimeFigureOut">
              <a:rPr lang="de-DE" smtClean="0"/>
              <a:t>31.05.2026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A768163-EFDA-999A-B3D2-35164B7EDF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3CE6653-9C47-35D6-578A-FF38608FED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F4243B7-592F-484F-AE41-8B9AA6081263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723808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feld 41">
            <a:extLst>
              <a:ext uri="{FF2B5EF4-FFF2-40B4-BE49-F238E27FC236}">
                <a16:creationId xmlns:a16="http://schemas.microsoft.com/office/drawing/2014/main" id="{A2EB86F5-9EDC-2260-F224-F5EB43710307}"/>
              </a:ext>
            </a:extLst>
          </p:cNvPr>
          <p:cNvSpPr txBox="1"/>
          <p:nvPr/>
        </p:nvSpPr>
        <p:spPr>
          <a:xfrm>
            <a:off x="3945289" y="4891677"/>
            <a:ext cx="49351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noProof="0" dirty="0">
                <a:latin typeface="Arial" panose="020B0604020202020204" pitchFamily="34" charset="0"/>
                <a:cs typeface="Arial" panose="020B0604020202020204" pitchFamily="34" charset="0"/>
              </a:rPr>
              <a:t>Suppl. Figure 1: Treatment strategies in tumor-associated UGIB </a:t>
            </a:r>
          </a:p>
        </p:txBody>
      </p:sp>
      <p:grpSp>
        <p:nvGrpSpPr>
          <p:cNvPr id="31" name="Gruppieren 30">
            <a:extLst>
              <a:ext uri="{FF2B5EF4-FFF2-40B4-BE49-F238E27FC236}">
                <a16:creationId xmlns:a16="http://schemas.microsoft.com/office/drawing/2014/main" id="{C936EF77-D818-00FC-B029-9BED62AF4E35}"/>
              </a:ext>
            </a:extLst>
          </p:cNvPr>
          <p:cNvGrpSpPr/>
          <p:nvPr/>
        </p:nvGrpSpPr>
        <p:grpSpPr>
          <a:xfrm>
            <a:off x="4703320" y="1965911"/>
            <a:ext cx="4326209" cy="2631290"/>
            <a:chOff x="4703320" y="1965911"/>
            <a:chExt cx="4326209" cy="2631290"/>
          </a:xfrm>
        </p:grpSpPr>
        <p:grpSp>
          <p:nvGrpSpPr>
            <p:cNvPr id="41" name="Gruppieren 40">
              <a:extLst>
                <a:ext uri="{FF2B5EF4-FFF2-40B4-BE49-F238E27FC236}">
                  <a16:creationId xmlns:a16="http://schemas.microsoft.com/office/drawing/2014/main" id="{06C98A50-466F-4A01-D0C9-D12BA402A26A}"/>
                </a:ext>
              </a:extLst>
            </p:cNvPr>
            <p:cNvGrpSpPr/>
            <p:nvPr/>
          </p:nvGrpSpPr>
          <p:grpSpPr>
            <a:xfrm>
              <a:off x="4703320" y="1965911"/>
              <a:ext cx="4326209" cy="2631290"/>
              <a:chOff x="7025066" y="1826211"/>
              <a:chExt cx="4326209" cy="2631290"/>
            </a:xfrm>
          </p:grpSpPr>
          <p:grpSp>
            <p:nvGrpSpPr>
              <p:cNvPr id="7" name="Gruppieren 6">
                <a:extLst>
                  <a:ext uri="{FF2B5EF4-FFF2-40B4-BE49-F238E27FC236}">
                    <a16:creationId xmlns:a16="http://schemas.microsoft.com/office/drawing/2014/main" id="{9217F125-D49D-78BE-DC95-E5EDB691B993}"/>
                  </a:ext>
                </a:extLst>
              </p:cNvPr>
              <p:cNvGrpSpPr/>
              <p:nvPr/>
            </p:nvGrpSpPr>
            <p:grpSpPr>
              <a:xfrm>
                <a:off x="7025066" y="1826211"/>
                <a:ext cx="4326209" cy="2631290"/>
                <a:chOff x="1600201" y="600076"/>
                <a:chExt cx="4326209" cy="2631290"/>
              </a:xfrm>
            </p:grpSpPr>
            <p:sp>
              <p:nvSpPr>
                <p:cNvPr id="8" name="Textfeld 7">
                  <a:extLst>
                    <a:ext uri="{FF2B5EF4-FFF2-40B4-BE49-F238E27FC236}">
                      <a16:creationId xmlns:a16="http://schemas.microsoft.com/office/drawing/2014/main" id="{412F86E7-B8D1-FC23-CEF5-69FCB90FC3E0}"/>
                    </a:ext>
                  </a:extLst>
                </p:cNvPr>
                <p:cNvSpPr txBox="1"/>
                <p:nvPr/>
              </p:nvSpPr>
              <p:spPr>
                <a:xfrm>
                  <a:off x="2992881" y="600076"/>
                  <a:ext cx="222528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noProof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dio-</a:t>
                  </a:r>
                  <a:r>
                    <a:rPr lang="en-US" sz="1400" noProof="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embolisation</a:t>
                  </a:r>
                  <a:r>
                    <a:rPr lang="en-US" sz="1400" noProof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6.7% </a:t>
                  </a:r>
                </a:p>
              </p:txBody>
            </p:sp>
            <p:sp>
              <p:nvSpPr>
                <p:cNvPr id="9" name="Textfeld 8">
                  <a:extLst>
                    <a:ext uri="{FF2B5EF4-FFF2-40B4-BE49-F238E27FC236}">
                      <a16:creationId xmlns:a16="http://schemas.microsoft.com/office/drawing/2014/main" id="{0ACC3935-661C-7882-0078-7CE86E568372}"/>
                    </a:ext>
                  </a:extLst>
                </p:cNvPr>
                <p:cNvSpPr txBox="1"/>
                <p:nvPr/>
              </p:nvSpPr>
              <p:spPr>
                <a:xfrm>
                  <a:off x="2979447" y="852066"/>
                  <a:ext cx="2762295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noProof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rgon plasma coagulation 6.7% </a:t>
                  </a:r>
                </a:p>
              </p:txBody>
            </p:sp>
            <p:sp>
              <p:nvSpPr>
                <p:cNvPr id="10" name="Textfeld 9">
                  <a:extLst>
                    <a:ext uri="{FF2B5EF4-FFF2-40B4-BE49-F238E27FC236}">
                      <a16:creationId xmlns:a16="http://schemas.microsoft.com/office/drawing/2014/main" id="{0BCE3AB4-480E-FDF3-AF52-4694F79D7FD6}"/>
                    </a:ext>
                  </a:extLst>
                </p:cNvPr>
                <p:cNvSpPr txBox="1"/>
                <p:nvPr/>
              </p:nvSpPr>
              <p:spPr>
                <a:xfrm>
                  <a:off x="2976748" y="1362089"/>
                  <a:ext cx="1907895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noProof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ip application 6.7% </a:t>
                  </a:r>
                </a:p>
              </p:txBody>
            </p:sp>
            <p:sp>
              <p:nvSpPr>
                <p:cNvPr id="11" name="Textfeld 10">
                  <a:extLst>
                    <a:ext uri="{FF2B5EF4-FFF2-40B4-BE49-F238E27FC236}">
                      <a16:creationId xmlns:a16="http://schemas.microsoft.com/office/drawing/2014/main" id="{7C95D192-00C7-137F-20A2-AE9625FE794F}"/>
                    </a:ext>
                  </a:extLst>
                </p:cNvPr>
                <p:cNvSpPr txBox="1"/>
                <p:nvPr/>
              </p:nvSpPr>
              <p:spPr>
                <a:xfrm>
                  <a:off x="2995517" y="2350790"/>
                  <a:ext cx="260086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noProof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emostatic powder 13.3% </a:t>
                  </a:r>
                </a:p>
              </p:txBody>
            </p:sp>
            <p:sp>
              <p:nvSpPr>
                <p:cNvPr id="12" name="Textfeld 11">
                  <a:extLst>
                    <a:ext uri="{FF2B5EF4-FFF2-40B4-BE49-F238E27FC236}">
                      <a16:creationId xmlns:a16="http://schemas.microsoft.com/office/drawing/2014/main" id="{E5FFE8AA-6BB3-C4DF-177A-7B35D5A9EC78}"/>
                    </a:ext>
                  </a:extLst>
                </p:cNvPr>
                <p:cNvSpPr txBox="1"/>
                <p:nvPr/>
              </p:nvSpPr>
              <p:spPr>
                <a:xfrm>
                  <a:off x="2995800" y="2923589"/>
                  <a:ext cx="293061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noProof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servative </a:t>
                  </a:r>
                  <a:r>
                    <a:rPr lang="en-US" sz="1400" noProof="0" dirty="0">
                      <a:highlight>
                        <a:srgbClr val="FFFFFF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management</a:t>
                  </a:r>
                  <a:r>
                    <a:rPr lang="en-US" sz="1400" noProof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53.3% </a:t>
                  </a:r>
                </a:p>
              </p:txBody>
            </p:sp>
            <p:cxnSp>
              <p:nvCxnSpPr>
                <p:cNvPr id="13" name="Verbinder: gewinkelt 12">
                  <a:extLst>
                    <a:ext uri="{FF2B5EF4-FFF2-40B4-BE49-F238E27FC236}">
                      <a16:creationId xmlns:a16="http://schemas.microsoft.com/office/drawing/2014/main" id="{1149C43A-A1BD-F5EA-BAC5-8F935A51BA7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15710" y="2975803"/>
                  <a:ext cx="1263737" cy="86286"/>
                </a:xfrm>
                <a:prstGeom prst="bentConnector3">
                  <a:avLst>
                    <a:gd name="adj1" fmla="val 556"/>
                  </a:avLst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Verbinder: gewinkelt 13">
                  <a:extLst>
                    <a:ext uri="{FF2B5EF4-FFF2-40B4-BE49-F238E27FC236}">
                      <a16:creationId xmlns:a16="http://schemas.microsoft.com/office/drawing/2014/main" id="{A7F540E4-5686-ACEC-159B-39B6F18A22F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600201" y="759566"/>
                  <a:ext cx="1389195" cy="281641"/>
                </a:xfrm>
                <a:prstGeom prst="bentConnector3">
                  <a:avLst>
                    <a:gd name="adj1" fmla="val 291"/>
                  </a:avLst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Verbinder: gewinkelt 14">
                  <a:extLst>
                    <a:ext uri="{FF2B5EF4-FFF2-40B4-BE49-F238E27FC236}">
                      <a16:creationId xmlns:a16="http://schemas.microsoft.com/office/drawing/2014/main" id="{EB26760A-75DE-2133-D400-94C11CD4EB5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055894" y="1018335"/>
                  <a:ext cx="936987" cy="45744"/>
                </a:xfrm>
                <a:prstGeom prst="bentConnector3">
                  <a:avLst>
                    <a:gd name="adj1" fmla="val 754"/>
                  </a:avLst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Gerader Verbinder 15">
                  <a:extLst>
                    <a:ext uri="{FF2B5EF4-FFF2-40B4-BE49-F238E27FC236}">
                      <a16:creationId xmlns:a16="http://schemas.microsoft.com/office/drawing/2014/main" id="{C88A8087-EE4F-7134-8212-F6379642E28E}"/>
                    </a:ext>
                  </a:extLst>
                </p:cNvPr>
                <p:cNvCxnSpPr>
                  <a:cxnSpLocks/>
                  <a:stCxn id="10" idx="1"/>
                </p:cNvCxnSpPr>
                <p:nvPr/>
              </p:nvCxnSpPr>
              <p:spPr>
                <a:xfrm flipH="1">
                  <a:off x="2732529" y="1515978"/>
                  <a:ext cx="24421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Gerader Verbinder 16">
                  <a:extLst>
                    <a:ext uri="{FF2B5EF4-FFF2-40B4-BE49-F238E27FC236}">
                      <a16:creationId xmlns:a16="http://schemas.microsoft.com/office/drawing/2014/main" id="{AA7230A1-4143-2805-F5EB-36ABF915B273}"/>
                    </a:ext>
                  </a:extLst>
                </p:cNvPr>
                <p:cNvCxnSpPr>
                  <a:cxnSpLocks/>
                  <a:stCxn id="11" idx="1"/>
                </p:cNvCxnSpPr>
                <p:nvPr/>
              </p:nvCxnSpPr>
              <p:spPr>
                <a:xfrm flipH="1">
                  <a:off x="2654214" y="2504679"/>
                  <a:ext cx="341303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8" name="Textfeld 27">
                <a:extLst>
                  <a:ext uri="{FF2B5EF4-FFF2-40B4-BE49-F238E27FC236}">
                    <a16:creationId xmlns:a16="http://schemas.microsoft.com/office/drawing/2014/main" id="{483A0E2B-5B10-B24D-3B07-A0F1D14CD2BF}"/>
                  </a:ext>
                </a:extLst>
              </p:cNvPr>
              <p:cNvSpPr txBox="1"/>
              <p:nvPr/>
            </p:nvSpPr>
            <p:spPr>
              <a:xfrm>
                <a:off x="8404312" y="2330192"/>
                <a:ext cx="257314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noProof="0" dirty="0">
                    <a:latin typeface="Arial" panose="020B0604020202020204" pitchFamily="34" charset="0"/>
                    <a:cs typeface="Arial" panose="020B0604020202020204" pitchFamily="34" charset="0"/>
                  </a:rPr>
                  <a:t>Radiofrequency ablation 6.7%</a:t>
                </a:r>
              </a:p>
            </p:txBody>
          </p:sp>
        </p:grpSp>
        <p:cxnSp>
          <p:nvCxnSpPr>
            <p:cNvPr id="2" name="Gerader Verbinder 1">
              <a:extLst>
                <a:ext uri="{FF2B5EF4-FFF2-40B4-BE49-F238E27FC236}">
                  <a16:creationId xmlns:a16="http://schemas.microsoft.com/office/drawing/2014/main" id="{923FBE20-1E36-7F60-8608-4CACD21F9C0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58367" y="2623780"/>
              <a:ext cx="5341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18" name="Grafik 17">
            <a:extLst>
              <a:ext uri="{FF2B5EF4-FFF2-40B4-BE49-F238E27FC236}">
                <a16:creationId xmlns:a16="http://schemas.microsoft.com/office/drawing/2014/main" id="{85BAD979-8361-D44F-F0D6-9470EF82134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28719"/>
          <a:stretch>
            <a:fillRect/>
          </a:stretch>
        </p:blipFill>
        <p:spPr>
          <a:xfrm rot="1306679">
            <a:off x="3901241" y="2329404"/>
            <a:ext cx="2011872" cy="2049780"/>
          </a:xfrm>
          <a:prstGeom prst="rect">
            <a:avLst/>
          </a:prstGeom>
        </p:spPr>
      </p:pic>
      <p:sp>
        <p:nvSpPr>
          <p:cNvPr id="22" name="Textfeld 21">
            <a:extLst>
              <a:ext uri="{FF2B5EF4-FFF2-40B4-BE49-F238E27FC236}">
                <a16:creationId xmlns:a16="http://schemas.microsoft.com/office/drawing/2014/main" id="{E01785BC-4657-8BA3-CCD0-39F4FCC92BCD}"/>
              </a:ext>
            </a:extLst>
          </p:cNvPr>
          <p:cNvSpPr txBox="1"/>
          <p:nvPr/>
        </p:nvSpPr>
        <p:spPr>
          <a:xfrm>
            <a:off x="6074817" y="3145112"/>
            <a:ext cx="38184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noProof="0" dirty="0">
                <a:latin typeface="Arial" panose="020B0604020202020204" pitchFamily="34" charset="0"/>
                <a:cs typeface="Arial" panose="020B0604020202020204" pitchFamily="34" charset="0"/>
              </a:rPr>
              <a:t>Clip application + Hemostatic powder 6.7% </a:t>
            </a:r>
          </a:p>
        </p:txBody>
      </p:sp>
      <p:cxnSp>
        <p:nvCxnSpPr>
          <p:cNvPr id="23" name="Gerader Verbinder 22">
            <a:extLst>
              <a:ext uri="{FF2B5EF4-FFF2-40B4-BE49-F238E27FC236}">
                <a16:creationId xmlns:a16="http://schemas.microsoft.com/office/drawing/2014/main" id="{2A168F0D-1C6E-627A-D95B-BDC420E2182D}"/>
              </a:ext>
            </a:extLst>
          </p:cNvPr>
          <p:cNvCxnSpPr>
            <a:cxnSpLocks/>
            <a:stCxn id="22" idx="1"/>
          </p:cNvCxnSpPr>
          <p:nvPr/>
        </p:nvCxnSpPr>
        <p:spPr>
          <a:xfrm flipH="1">
            <a:off x="5897244" y="3299001"/>
            <a:ext cx="17757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10455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5205C60-D900-FC45-1204-73F4627A662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uppieren 20">
            <a:extLst>
              <a:ext uri="{FF2B5EF4-FFF2-40B4-BE49-F238E27FC236}">
                <a16:creationId xmlns:a16="http://schemas.microsoft.com/office/drawing/2014/main" id="{6B8D16EF-32A6-44D2-B165-08777893735C}"/>
              </a:ext>
            </a:extLst>
          </p:cNvPr>
          <p:cNvGrpSpPr/>
          <p:nvPr/>
        </p:nvGrpSpPr>
        <p:grpSpPr>
          <a:xfrm>
            <a:off x="2968116" y="840727"/>
            <a:ext cx="6081524" cy="4568443"/>
            <a:chOff x="2995010" y="132515"/>
            <a:chExt cx="6081524" cy="4568443"/>
          </a:xfrm>
        </p:grpSpPr>
        <p:sp>
          <p:nvSpPr>
            <p:cNvPr id="3" name="Textfeld 2">
              <a:extLst>
                <a:ext uri="{FF2B5EF4-FFF2-40B4-BE49-F238E27FC236}">
                  <a16:creationId xmlns:a16="http://schemas.microsoft.com/office/drawing/2014/main" id="{26D6284E-ECC9-4DA0-050B-C925DD9E070F}"/>
                </a:ext>
              </a:extLst>
            </p:cNvPr>
            <p:cNvSpPr txBox="1"/>
            <p:nvPr/>
          </p:nvSpPr>
          <p:spPr>
            <a:xfrm>
              <a:off x="3827185" y="4423959"/>
              <a:ext cx="52490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uppl. Figure 2: Overall survival following UGIB in patients with BTC</a:t>
              </a:r>
              <a:endParaRPr lang="en-US" sz="1200" b="1" noProof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" name="Gruppieren 14">
              <a:extLst>
                <a:ext uri="{FF2B5EF4-FFF2-40B4-BE49-F238E27FC236}">
                  <a16:creationId xmlns:a16="http://schemas.microsoft.com/office/drawing/2014/main" id="{99272442-EE3C-1246-4EFD-5C84A601F521}"/>
                </a:ext>
              </a:extLst>
            </p:cNvPr>
            <p:cNvGrpSpPr/>
            <p:nvPr/>
          </p:nvGrpSpPr>
          <p:grpSpPr>
            <a:xfrm>
              <a:off x="3827185" y="506792"/>
              <a:ext cx="5249349" cy="3482500"/>
              <a:chOff x="3827185" y="506792"/>
              <a:chExt cx="5249349" cy="3482500"/>
            </a:xfrm>
          </p:grpSpPr>
          <p:pic>
            <p:nvPicPr>
              <p:cNvPr id="13" name="Grafik 12">
                <a:extLst>
                  <a:ext uri="{FF2B5EF4-FFF2-40B4-BE49-F238E27FC236}">
                    <a16:creationId xmlns:a16="http://schemas.microsoft.com/office/drawing/2014/main" id="{68E9528F-0137-4CBA-3B2F-BE979C9AAB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21" t="16375" b="29948"/>
              <a:stretch>
                <a:fillRect/>
              </a:stretch>
            </p:blipFill>
            <p:spPr>
              <a:xfrm>
                <a:off x="3827185" y="506792"/>
                <a:ext cx="5249349" cy="2290482"/>
              </a:xfrm>
              <a:prstGeom prst="rect">
                <a:avLst/>
              </a:prstGeom>
            </p:spPr>
          </p:pic>
          <p:pic>
            <p:nvPicPr>
              <p:cNvPr id="14" name="Grafik 13">
                <a:extLst>
                  <a:ext uri="{FF2B5EF4-FFF2-40B4-BE49-F238E27FC236}">
                    <a16:creationId xmlns:a16="http://schemas.microsoft.com/office/drawing/2014/main" id="{C74E0075-0426-29FB-6A59-77EBB53E81D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21" t="80163" b="5335"/>
              <a:stretch>
                <a:fillRect/>
              </a:stretch>
            </p:blipFill>
            <p:spPr>
              <a:xfrm>
                <a:off x="3827185" y="3370443"/>
                <a:ext cx="5249349" cy="618849"/>
              </a:xfrm>
              <a:prstGeom prst="rect">
                <a:avLst/>
              </a:prstGeom>
            </p:spPr>
          </p:pic>
        </p:grpSp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ED84A9E3-AA1D-1F6A-D5E5-15BBF1564551}"/>
                </a:ext>
              </a:extLst>
            </p:cNvPr>
            <p:cNvSpPr txBox="1"/>
            <p:nvPr/>
          </p:nvSpPr>
          <p:spPr>
            <a:xfrm>
              <a:off x="5111635" y="2958354"/>
              <a:ext cx="30390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ays after </a:t>
              </a:r>
              <a:r>
                <a:rPr lang="de-DE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dex</a:t>
              </a:r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UGIB</a:t>
              </a:r>
            </a:p>
          </p:txBody>
        </p:sp>
        <p:sp>
          <p:nvSpPr>
            <p:cNvPr id="19" name="Textfeld 18">
              <a:extLst>
                <a:ext uri="{FF2B5EF4-FFF2-40B4-BE49-F238E27FC236}">
                  <a16:creationId xmlns:a16="http://schemas.microsoft.com/office/drawing/2014/main" id="{14C4F6B3-C38C-26BA-A51E-5FEF7433C033}"/>
                </a:ext>
              </a:extLst>
            </p:cNvPr>
            <p:cNvSpPr txBox="1"/>
            <p:nvPr/>
          </p:nvSpPr>
          <p:spPr>
            <a:xfrm>
              <a:off x="2995010" y="3449034"/>
              <a:ext cx="95704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umber at </a:t>
              </a:r>
              <a:r>
                <a:rPr lang="de-DE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isk</a:t>
              </a:r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†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feld 19">
              <a:extLst>
                <a:ext uri="{FF2B5EF4-FFF2-40B4-BE49-F238E27FC236}">
                  <a16:creationId xmlns:a16="http://schemas.microsoft.com/office/drawing/2014/main" id="{82DEBD60-0FCE-8C35-DC11-5B21BB94E1CF}"/>
                </a:ext>
              </a:extLst>
            </p:cNvPr>
            <p:cNvSpPr txBox="1"/>
            <p:nvPr/>
          </p:nvSpPr>
          <p:spPr>
            <a:xfrm rot="16200000">
              <a:off x="1954015" y="1513533"/>
              <a:ext cx="30390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Overall </a:t>
              </a:r>
              <a:r>
                <a:rPr lang="de-DE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urvival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" name="Textfeld 22">
            <a:extLst>
              <a:ext uri="{FF2B5EF4-FFF2-40B4-BE49-F238E27FC236}">
                <a16:creationId xmlns:a16="http://schemas.microsoft.com/office/drawing/2014/main" id="{DD17B6FD-C43F-7536-D060-DFE3AEC04179}"/>
              </a:ext>
            </a:extLst>
          </p:cNvPr>
          <p:cNvSpPr txBox="1"/>
          <p:nvPr/>
        </p:nvSpPr>
        <p:spPr>
          <a:xfrm>
            <a:off x="3800291" y="5409170"/>
            <a:ext cx="514169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Overall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UGIB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GIB: upper gastrointestinal bleeding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† Patients who underwent curative tumor resection after index bleeding were excluded from subsequent survival and re-bleeding analysis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68604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7</Words>
  <Application>Microsoft Office PowerPoint</Application>
  <PresentationFormat>Breitbild</PresentationFormat>
  <Paragraphs>16</Paragraphs>
  <Slides>2</Slides>
  <Notes>2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ristoph Schumacher</dc:creator>
  <cp:lastModifiedBy>Christoph Schumacher</cp:lastModifiedBy>
  <cp:revision>137</cp:revision>
  <dcterms:created xsi:type="dcterms:W3CDTF">2024-09-01T19:13:54Z</dcterms:created>
  <dcterms:modified xsi:type="dcterms:W3CDTF">2026-05-31T16:14:17Z</dcterms:modified>
</cp:coreProperties>
</file>